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 flipV="1">
            <a:off x="2490729" y="2120050"/>
            <a:ext cx="148820" cy="1711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 flipH="1" flipV="1">
            <a:off x="2220916" y="2065052"/>
            <a:ext cx="138545" cy="19805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A picture containing jellyfish&#10;&#10;Description automatically generated">
            <a:extLst>
              <a:ext uri="{FF2B5EF4-FFF2-40B4-BE49-F238E27FC236}">
                <a16:creationId xmlns:a16="http://schemas.microsoft.com/office/drawing/2014/main" id="{C8631630-8A4D-614A-C9A7-CADB44272E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42" y="692569"/>
            <a:ext cx="4022515" cy="2195214"/>
          </a:xfrm>
          <a:prstGeom prst="rect">
            <a:avLst/>
          </a:prstGeom>
        </p:spPr>
      </p:pic>
      <p:pic>
        <p:nvPicPr>
          <p:cNvPr id="6" name="Picture 5" descr="A picture containing invertebrate, coelenterate, jellyfish, blurry&#10;&#10;Description automatically generated">
            <a:extLst>
              <a:ext uri="{FF2B5EF4-FFF2-40B4-BE49-F238E27FC236}">
                <a16:creationId xmlns:a16="http://schemas.microsoft.com/office/drawing/2014/main" id="{EF414D02-5FD9-0A9A-3727-B757F11D2C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2993" y="649646"/>
            <a:ext cx="4000971" cy="223813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288800" y="2518451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705_Brain 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F962C7D-38E3-994A-792D-AA0D608BB89E}"/>
              </a:ext>
            </a:extLst>
          </p:cNvPr>
          <p:cNvSpPr txBox="1"/>
          <p:nvPr/>
        </p:nvSpPr>
        <p:spPr>
          <a:xfrm>
            <a:off x="4108566" y="2518451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705_Brain 2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1154CA7-F10A-03B7-763F-095A15A7E9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90556" y="714217"/>
            <a:ext cx="4031566" cy="2364377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CE4BFF74-8406-C76B-6E98-75E70127E25D}"/>
              </a:ext>
            </a:extLst>
          </p:cNvPr>
          <p:cNvSpPr txBox="1"/>
          <p:nvPr/>
        </p:nvSpPr>
        <p:spPr>
          <a:xfrm>
            <a:off x="8826927" y="2738093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172_Brain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A158F23-383E-34B1-F05B-D473B0A2F563}"/>
              </a:ext>
            </a:extLst>
          </p:cNvPr>
          <p:cNvSpPr txBox="1"/>
          <p:nvPr/>
        </p:nvSpPr>
        <p:spPr>
          <a:xfrm>
            <a:off x="8419475" y="208773"/>
            <a:ext cx="2567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arval neuron MBON-e2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96053B6-3B81-C826-5BC5-1A821069B375}"/>
              </a:ext>
            </a:extLst>
          </p:cNvPr>
          <p:cNvSpPr txBox="1"/>
          <p:nvPr/>
        </p:nvSpPr>
        <p:spPr>
          <a:xfrm>
            <a:off x="8743544" y="4180365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172_Brain 1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C925AA77-6251-708F-14AB-9FF2F19B9696}"/>
              </a:ext>
            </a:extLst>
          </p:cNvPr>
          <p:cNvCxnSpPr>
            <a:cxnSpLocks/>
          </p:cNvCxnSpPr>
          <p:nvPr/>
        </p:nvCxnSpPr>
        <p:spPr>
          <a:xfrm flipH="1" flipV="1">
            <a:off x="10496011" y="1069672"/>
            <a:ext cx="274951" cy="3164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D15874B8-A82F-9C90-F13D-BFED444583DD}"/>
              </a:ext>
            </a:extLst>
          </p:cNvPr>
          <p:cNvCxnSpPr>
            <a:cxnSpLocks/>
          </p:cNvCxnSpPr>
          <p:nvPr/>
        </p:nvCxnSpPr>
        <p:spPr>
          <a:xfrm flipH="1" flipV="1">
            <a:off x="10152614" y="1474225"/>
            <a:ext cx="121329" cy="363885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CDD274A-11FC-CAF0-2B06-4488F494918F}"/>
              </a:ext>
            </a:extLst>
          </p:cNvPr>
          <p:cNvGrpSpPr/>
          <p:nvPr/>
        </p:nvGrpSpPr>
        <p:grpSpPr>
          <a:xfrm>
            <a:off x="67620" y="3524702"/>
            <a:ext cx="12050229" cy="2292284"/>
            <a:chOff x="-3255368" y="2968593"/>
            <a:chExt cx="15287733" cy="2908147"/>
          </a:xfrm>
        </p:grpSpPr>
        <p:pic>
          <p:nvPicPr>
            <p:cNvPr id="12" name="Picture 11" descr="A picture containing dark, light, blurry, ocean floor&#10;&#10;Description automatically generated">
              <a:extLst>
                <a:ext uri="{FF2B5EF4-FFF2-40B4-BE49-F238E27FC236}">
                  <a16:creationId xmlns:a16="http://schemas.microsoft.com/office/drawing/2014/main" id="{0EBC97DE-BE47-E7D9-E504-971D9B2826D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3255368" y="2968593"/>
              <a:ext cx="4778216" cy="2908147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2F53E0C-EFE8-D2AA-AB41-3AA3C1D17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86432" y="3059131"/>
              <a:ext cx="5083535" cy="2732592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77EE87B3-0596-973A-DCDD-901E42499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956463" y="3059131"/>
              <a:ext cx="5075902" cy="2763124"/>
            </a:xfrm>
            <a:prstGeom prst="rect">
              <a:avLst/>
            </a:prstGeom>
          </p:spPr>
        </p:pic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E2662A55-2FD3-A0F2-C549-6C5DB1914475}"/>
              </a:ext>
            </a:extLst>
          </p:cNvPr>
          <p:cNvSpPr txBox="1"/>
          <p:nvPr/>
        </p:nvSpPr>
        <p:spPr>
          <a:xfrm>
            <a:off x="118417" y="54105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328_Brain 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4BDE7DB-A63D-B1EE-184D-1697DBB152BD}"/>
              </a:ext>
            </a:extLst>
          </p:cNvPr>
          <p:cNvSpPr txBox="1"/>
          <p:nvPr/>
        </p:nvSpPr>
        <p:spPr>
          <a:xfrm>
            <a:off x="3962888" y="54105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328_Brain 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6969B65-1E11-EE4B-269B-F91F970C9B33}"/>
              </a:ext>
            </a:extLst>
          </p:cNvPr>
          <p:cNvSpPr txBox="1"/>
          <p:nvPr/>
        </p:nvSpPr>
        <p:spPr>
          <a:xfrm>
            <a:off x="8201367" y="541059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4328_Brain 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DD1B6C4-15C0-E519-8EAE-AF0F1CE161FD}"/>
              </a:ext>
            </a:extLst>
          </p:cNvPr>
          <p:cNvSpPr txBox="1"/>
          <p:nvPr/>
        </p:nvSpPr>
        <p:spPr>
          <a:xfrm>
            <a:off x="62651" y="3045386"/>
            <a:ext cx="5447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ON-f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BA5D605-1A5A-3B22-80EB-D7048CE2862E}"/>
              </a:ext>
            </a:extLst>
          </p:cNvPr>
          <p:cNvSpPr txBox="1"/>
          <p:nvPr/>
        </p:nvSpPr>
        <p:spPr>
          <a:xfrm>
            <a:off x="15942" y="273786"/>
            <a:ext cx="5707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ON-d1</a:t>
            </a:r>
          </a:p>
        </p:txBody>
      </p:sp>
    </p:spTree>
    <p:extLst>
      <p:ext uri="{BB962C8B-B14F-4D97-AF65-F5344CB8AC3E}">
        <p14:creationId xmlns:p14="http://schemas.microsoft.com/office/powerpoint/2010/main" val="3084341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45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2</cp:revision>
  <dcterms:created xsi:type="dcterms:W3CDTF">2022-06-08T22:16:26Z</dcterms:created>
  <dcterms:modified xsi:type="dcterms:W3CDTF">2022-06-08T22:54:03Z</dcterms:modified>
</cp:coreProperties>
</file>